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244" autoAdjust="0"/>
    <p:restoredTop sz="72924"/>
  </p:normalViewPr>
  <p:slideViewPr>
    <p:cSldViewPr snapToGrid="0">
      <p:cViewPr varScale="1">
        <p:scale>
          <a:sx n="66" d="100"/>
          <a:sy n="66" d="100"/>
        </p:scale>
        <p:origin x="15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93DA90-B7C0-DD42-BBA1-BB9AE30A0343}" type="datetimeFigureOut">
              <a:rPr lang="en-US" smtClean="0"/>
              <a:t>4/16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6C8F8E-62B7-A34E-BB29-546ECEE013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9723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B6C8F8E-62B7-A34E-BB29-546ECEE0132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0272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855655F2-0597-442C-A8EA-13567347886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="" xmlns:a16="http://schemas.microsoft.com/office/drawing/2014/main" id="{CDFEF5DB-63A5-4C30-8F1C-0D21515EFB8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540C2D9A-2D20-414F-91C7-B8A644929D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9A57C-5450-422B-AD35-21FAB49B76F6}" type="datetimeFigureOut">
              <a:rPr lang="zh-CN" altLang="en-US" smtClean="0"/>
              <a:t>19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C27AA2EE-A901-4071-B99B-0D41AFCD7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F94C32C4-D1A2-4959-BA0B-E1CD83E2A2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F5782-222D-499B-8718-3AE905E2B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9848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0E619445-6E4D-4523-BA6A-BC084719FC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DC746CC7-09F7-4832-B645-2189D38C99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26E18AF2-DC85-479B-AB62-C7DDD08447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9A57C-5450-422B-AD35-21FAB49B76F6}" type="datetimeFigureOut">
              <a:rPr lang="zh-CN" altLang="en-US" smtClean="0"/>
              <a:t>19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BCB95506-FCED-4CFA-9E9D-A29E49062A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6BB8197B-769C-454C-B5A5-8EC2DFD0BB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F5782-222D-499B-8718-3AE905E2B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9895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="" xmlns:a16="http://schemas.microsoft.com/office/drawing/2014/main" id="{B24CBFAB-0C85-447E-9ED0-1B2FAB1643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AA064EDE-B29A-4DB2-87FE-A9A3BA3DC7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F7712508-60A8-4521-81F4-DD648359A6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9A57C-5450-422B-AD35-21FAB49B76F6}" type="datetimeFigureOut">
              <a:rPr lang="zh-CN" altLang="en-US" smtClean="0"/>
              <a:t>19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3BBBBF64-EC39-41CC-A7C3-2D9601C229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49DA0074-F72A-4F73-A14A-85B7EF593B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F5782-222D-499B-8718-3AE905E2B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4683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09718451-E650-4463-AB97-FB5BA64003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113A9FD0-CBCE-4F4A-967D-1A74B5BE1C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6EF3750F-7CBC-4775-8D57-0BEED0D9F9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9A57C-5450-422B-AD35-21FAB49B76F6}" type="datetimeFigureOut">
              <a:rPr lang="zh-CN" altLang="en-US" smtClean="0"/>
              <a:t>19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F1E5D402-D7B2-4E6A-B06C-5037F2923C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FFC177EC-F368-4999-919E-C3825C5097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F5782-222D-499B-8718-3AE905E2B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8401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6A6224BF-62AA-4052-8F7A-8C605A0BA6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DE557332-0126-45C6-ACBB-4DC7797D0B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7089F1A5-4F2E-4F8C-811F-12A5E30B94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9A57C-5450-422B-AD35-21FAB49B76F6}" type="datetimeFigureOut">
              <a:rPr lang="zh-CN" altLang="en-US" smtClean="0"/>
              <a:t>19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3147F652-58AF-497B-9751-009861C6F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45DC6A08-345E-443A-A02E-B23044AC26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F5782-222D-499B-8718-3AE905E2B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66427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BE1E2589-5D8E-464D-8F61-B6326B7D52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BC360D8A-4B5A-42F2-ADD1-6DAF2841872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7C3CBDA5-5A27-4FDA-90F4-1337AFAE7C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DC8A9778-042F-4ADD-9CDD-F4FE25DE4A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9A57C-5450-422B-AD35-21FAB49B76F6}" type="datetimeFigureOut">
              <a:rPr lang="zh-CN" altLang="en-US" smtClean="0"/>
              <a:t>19/4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3E3617F9-5605-47E8-ADCC-F93815F2CE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E3439BB3-8F05-4AF4-A8EB-C658E2711A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F5782-222D-499B-8718-3AE905E2B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06947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1DC33FA9-EB44-4D2B-9AB5-D21866A30A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7B962006-534C-47BE-B377-1B48A9BAA7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9CE5E8F2-B6F0-4C5F-90D6-FA2F427D30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="" xmlns:a16="http://schemas.microsoft.com/office/drawing/2014/main" id="{5F6BF833-9AC3-4866-B184-7223CFD54DA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="" xmlns:a16="http://schemas.microsoft.com/office/drawing/2014/main" id="{3BFA63DF-259B-4A53-8A4B-6894B7DAAA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="" xmlns:a16="http://schemas.microsoft.com/office/drawing/2014/main" id="{E07D3275-56B3-482D-8B64-6E075DA22D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9A57C-5450-422B-AD35-21FAB49B76F6}" type="datetimeFigureOut">
              <a:rPr lang="zh-CN" altLang="en-US" smtClean="0"/>
              <a:t>19/4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="" xmlns:a16="http://schemas.microsoft.com/office/drawing/2014/main" id="{5EE39BF0-422F-4994-B5A4-7E3279099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="" xmlns:a16="http://schemas.microsoft.com/office/drawing/2014/main" id="{78E4714F-166A-46B6-93CB-61B50E8E8B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F5782-222D-499B-8718-3AE905E2B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970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D7CF2A2A-8397-4201-8055-8EBD0B2ED7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="" xmlns:a16="http://schemas.microsoft.com/office/drawing/2014/main" id="{9CCA6CD9-7CDD-41DC-B1F7-9E41C127E9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9A57C-5450-422B-AD35-21FAB49B76F6}" type="datetimeFigureOut">
              <a:rPr lang="zh-CN" altLang="en-US" smtClean="0"/>
              <a:t>19/4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="" xmlns:a16="http://schemas.microsoft.com/office/drawing/2014/main" id="{6B7EE24A-4E9D-4547-8226-E09DEA9F94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="" xmlns:a16="http://schemas.microsoft.com/office/drawing/2014/main" id="{C8F54C19-5E06-4728-A238-A464722EC0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F5782-222D-499B-8718-3AE905E2B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12548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="" xmlns:a16="http://schemas.microsoft.com/office/drawing/2014/main" id="{E9670E5E-5710-4535-AB9C-440DCE246D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9A57C-5450-422B-AD35-21FAB49B76F6}" type="datetimeFigureOut">
              <a:rPr lang="zh-CN" altLang="en-US" smtClean="0"/>
              <a:t>19/4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="" xmlns:a16="http://schemas.microsoft.com/office/drawing/2014/main" id="{074C5544-2A30-4071-A2B9-BD79962D1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="" xmlns:a16="http://schemas.microsoft.com/office/drawing/2014/main" id="{7EFA6CCB-7083-43EE-A70A-36DE9ABA01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F5782-222D-499B-8718-3AE905E2B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3302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A6F4568-78FF-4729-8D4A-90488571B4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785A2A3A-0D25-40E2-BC79-EBB54886DE7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889182A4-2BA3-40CC-A1AE-25CDC30531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C3F8181B-86BA-487A-81BB-3CDAC3384E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9A57C-5450-422B-AD35-21FAB49B76F6}" type="datetimeFigureOut">
              <a:rPr lang="zh-CN" altLang="en-US" smtClean="0"/>
              <a:t>19/4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CB51DBEC-C806-4CFB-AEEF-7FEC6D8C4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3A5C77FB-3F9E-4FD8-80A9-31F452BA87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F5782-222D-499B-8718-3AE905E2B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4405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EA83E249-3CB3-4861-AE7C-4CE1C417BE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="" xmlns:a16="http://schemas.microsoft.com/office/drawing/2014/main" id="{27C217FA-FA77-4BEB-BD35-D546C2671B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809F7A13-6583-41DD-ADEF-6AAC1BC80F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1D31FE16-8CB7-493A-ABA7-500F17D3B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9A57C-5450-422B-AD35-21FAB49B76F6}" type="datetimeFigureOut">
              <a:rPr lang="zh-CN" altLang="en-US" smtClean="0"/>
              <a:t>19/4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9099B7C8-42A9-47D0-B494-2C0091412B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1E07B5A3-88EB-4728-831E-E87FCE9E41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4F5782-222D-499B-8718-3AE905E2B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9433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="" xmlns:a16="http://schemas.microsoft.com/office/drawing/2014/main" id="{38D8500D-31D2-4533-9064-DB03F4C971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ECDEA732-ACE3-4618-9135-1A75B4E54C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14DFA2A3-20F9-446F-BE6D-83F8B24ECF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49A57C-5450-422B-AD35-21FAB49B76F6}" type="datetimeFigureOut">
              <a:rPr lang="zh-CN" altLang="en-US" smtClean="0"/>
              <a:t>19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2C9C0EA8-3A35-4B84-A9B5-98317760D8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F4A38A6A-2D33-4078-96C0-FB8465FE67C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4F5782-222D-499B-8718-3AE905E2B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23724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="" xmlns:a16="http://schemas.microsoft.com/office/drawing/2014/main" id="{551F9AC8-EA93-4C81-A78B-D92B8CDDA0E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733" y="184457"/>
            <a:ext cx="6673543" cy="6673543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7315200" y="502970"/>
            <a:ext cx="4182894" cy="31393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Arial" charset="0"/>
                <a:ea typeface="Arial" charset="0"/>
                <a:cs typeface="Arial" charset="0"/>
              </a:rPr>
              <a:t>Supplementary Figure1. Accuracy of OrthoVenn2 and other </a:t>
            </a:r>
            <a:r>
              <a:rPr lang="en-US" dirty="0" err="1">
                <a:latin typeface="Arial" charset="0"/>
                <a:ea typeface="Arial" charset="0"/>
                <a:cs typeface="Arial" charset="0"/>
              </a:rPr>
              <a:t>orthology</a:t>
            </a:r>
            <a:r>
              <a:rPr lang="en-US" dirty="0">
                <a:latin typeface="Arial" charset="0"/>
                <a:ea typeface="Arial" charset="0"/>
                <a:cs typeface="Arial" charset="0"/>
              </a:rPr>
              <a:t> inference tools assessed by the </a:t>
            </a:r>
            <a:r>
              <a:rPr lang="en-US" dirty="0" err="1">
                <a:latin typeface="Arial" charset="0"/>
                <a:ea typeface="Arial" charset="0"/>
                <a:cs typeface="Arial" charset="0"/>
              </a:rPr>
              <a:t>QfO</a:t>
            </a:r>
            <a:r>
              <a:rPr lang="en-US" dirty="0">
                <a:latin typeface="Arial" charset="0"/>
                <a:ea typeface="Arial" charset="0"/>
                <a:cs typeface="Arial" charset="0"/>
              </a:rPr>
              <a:t> benchmark (generalized species tree discordance test at the last universal common ancestor level). The x-axis represents the numbers of completed tree samples out of 50 000 trials (larger is better), while the y-axis represents the average tree error (smaller is better).</a:t>
            </a:r>
          </a:p>
        </p:txBody>
      </p:sp>
    </p:spTree>
    <p:extLst>
      <p:ext uri="{BB962C8B-B14F-4D97-AF65-F5344CB8AC3E}">
        <p14:creationId xmlns:p14="http://schemas.microsoft.com/office/powerpoint/2010/main" val="3068518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8</TotalTime>
  <Words>6</Words>
  <Application>Microsoft Macintosh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等线</vt:lpstr>
      <vt:lpstr>等线 Light</vt:lpstr>
      <vt:lpstr>Office 主题​​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Ling Xu</cp:lastModifiedBy>
  <cp:revision>10</cp:revision>
  <dcterms:created xsi:type="dcterms:W3CDTF">2019-04-11T03:32:02Z</dcterms:created>
  <dcterms:modified xsi:type="dcterms:W3CDTF">2019-04-17T03:53:52Z</dcterms:modified>
</cp:coreProperties>
</file>